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108" y="6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3/01/2021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505841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88995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3/0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Douglas Melton (2021) Diabetologia DOI 10.1007/s00125-020-05367-2 </a:t>
            </a:r>
          </a:p>
          <a:p>
            <a:r>
              <a:rPr lang="en-GB" sz="1200" dirty="0"/>
              <a:t>©The Author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79512" y="188640"/>
            <a:ext cx="878497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 stem cell-derived islet produced from human embryonic stem cells by a six-step differentiation procedure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DE06E15-12C1-4685-8DD5-3C9D062F386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11760" y="1073543"/>
            <a:ext cx="4933553" cy="4424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9512" y="188640"/>
            <a:ext cx="8784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reating stem cell-derived islets (SC-islets) of defined cell composi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D852ADF-D1BD-44FD-A529-8364F050E1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1824" y="920293"/>
            <a:ext cx="7740352" cy="4519491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718013F-1556-48E2-B439-6E5A080501BA}"/>
              </a:ext>
            </a:extLst>
          </p:cNvPr>
          <p:cNvSpPr txBox="1"/>
          <p:nvPr/>
        </p:nvSpPr>
        <p:spPr>
          <a:xfrm>
            <a:off x="3995936" y="2348880"/>
            <a:ext cx="8640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50 µm</a:t>
            </a:r>
            <a:endParaRPr lang="en-GB" sz="1200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B9B95-D12A-422E-A14A-30E02D92A3B0}"/>
              </a:ext>
            </a:extLst>
          </p:cNvPr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Douglas Melton (2021) Diabetologia DOI 10.1007/s00125-020-05367-2 </a:t>
            </a:r>
          </a:p>
          <a:p>
            <a:r>
              <a:rPr lang="en-GB" sz="1200" dirty="0"/>
              <a:t>©The Author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3844747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9512" y="188640"/>
            <a:ext cx="83529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ossible uses and advances for in vitro studies and clinical applications of stem cell-derived islets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0FDE3A0-4646-4962-B617-1C2491F07B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6914" y="1040989"/>
            <a:ext cx="4290172" cy="490829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174B4BD-7D8D-4669-B06D-958BCE318528}"/>
              </a:ext>
            </a:extLst>
          </p:cNvPr>
          <p:cNvSpPr txBox="1"/>
          <p:nvPr/>
        </p:nvSpPr>
        <p:spPr>
          <a:xfrm>
            <a:off x="251520" y="5805264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Douglas Melton (2021) Diabetologia DOI 10.1007/s00125-020-05367-2 </a:t>
            </a:r>
          </a:p>
          <a:p>
            <a:r>
              <a:rPr lang="en-GB" sz="1200" dirty="0"/>
              <a:t>©The Author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893438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163</Words>
  <Application>Microsoft Office PowerPoint</Application>
  <PresentationFormat>On-screen Show (4:3)</PresentationFormat>
  <Paragraphs>16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7</cp:revision>
  <dcterms:created xsi:type="dcterms:W3CDTF">2016-06-15T12:53:43Z</dcterms:created>
  <dcterms:modified xsi:type="dcterms:W3CDTF">2021-01-13T12:11:01Z</dcterms:modified>
</cp:coreProperties>
</file>